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3" r:id="rId1"/>
  </p:sldMasterIdLst>
  <p:notesMasterIdLst>
    <p:notesMasterId r:id="rId3"/>
  </p:notesMasterIdLst>
  <p:sldIdLst>
    <p:sldId id="377" r:id="rId2"/>
  </p:sldIdLst>
  <p:sldSz cx="17340263" cy="9753600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" id="{57B91B71-F9E2-4793-BD14-5C610AA0980B}">
          <p14:sldIdLst>
            <p14:sldId id="37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K" initials="A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00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00"/>
    <a:srgbClr val="E2E2E2"/>
    <a:srgbClr val="BFBFBF"/>
    <a:srgbClr val="FF7F0E"/>
    <a:srgbClr val="F44849"/>
    <a:srgbClr val="0000F7"/>
    <a:srgbClr val="64B5CD"/>
    <a:srgbClr val="CCB974"/>
    <a:srgbClr val="8C8C8C"/>
    <a:srgbClr val="DA8B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07" autoAdjust="0"/>
    <p:restoredTop sz="87225" autoAdjust="0"/>
  </p:normalViewPr>
  <p:slideViewPr>
    <p:cSldViewPr snapToGrid="0" snapToObjects="1">
      <p:cViewPr varScale="1">
        <p:scale>
          <a:sx n="77" d="100"/>
          <a:sy n="77" d="100"/>
        </p:scale>
        <p:origin x="896" y="19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Shape 116"/>
          <p:cNvSpPr>
            <a:spLocks noGrp="1" noRot="1" noChangeAspect="1"/>
          </p:cNvSpPr>
          <p:nvPr>
            <p:ph type="sldImg"/>
          </p:nvPr>
        </p:nvSpPr>
        <p:spPr>
          <a:xfrm>
            <a:off x="325438" y="698500"/>
            <a:ext cx="6207125" cy="34925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7" name="Shape 117"/>
          <p:cNvSpPr>
            <a:spLocks noGrp="1"/>
          </p:cNvSpPr>
          <p:nvPr>
            <p:ph type="body" sz="quarter" idx="1"/>
          </p:nvPr>
        </p:nvSpPr>
        <p:spPr>
          <a:xfrm>
            <a:off x="914400" y="4424085"/>
            <a:ext cx="5029200" cy="4191238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0BA89B6-98CE-4F9C-80FC-B04438EE83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167533" y="1596249"/>
            <a:ext cx="13005197" cy="3395698"/>
          </a:xfrm>
        </p:spPr>
        <p:txBody>
          <a:bodyPr anchor="b"/>
          <a:lstStyle>
            <a:lvl1pPr algn="ctr">
              <a:defRPr sz="853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8936271-DDA6-44B2-B98E-759A99146B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167533" y="5122898"/>
            <a:ext cx="13005197" cy="2354862"/>
          </a:xfrm>
        </p:spPr>
        <p:txBody>
          <a:bodyPr/>
          <a:lstStyle>
            <a:lvl1pPr marL="0" indent="0" algn="ctr">
              <a:buNone/>
              <a:defRPr sz="3413"/>
            </a:lvl1pPr>
            <a:lvl2pPr marL="650230" indent="0" algn="ctr">
              <a:buNone/>
              <a:defRPr sz="2844"/>
            </a:lvl2pPr>
            <a:lvl3pPr marL="1300460" indent="0" algn="ctr">
              <a:buNone/>
              <a:defRPr sz="2560"/>
            </a:lvl3pPr>
            <a:lvl4pPr marL="1950690" indent="0" algn="ctr">
              <a:buNone/>
              <a:defRPr sz="2276"/>
            </a:lvl4pPr>
            <a:lvl5pPr marL="2600919" indent="0" algn="ctr">
              <a:buNone/>
              <a:defRPr sz="2276"/>
            </a:lvl5pPr>
            <a:lvl6pPr marL="3251149" indent="0" algn="ctr">
              <a:buNone/>
              <a:defRPr sz="2276"/>
            </a:lvl6pPr>
            <a:lvl7pPr marL="3901379" indent="0" algn="ctr">
              <a:buNone/>
              <a:defRPr sz="2276"/>
            </a:lvl7pPr>
            <a:lvl8pPr marL="4551609" indent="0" algn="ctr">
              <a:buNone/>
              <a:defRPr sz="2276"/>
            </a:lvl8pPr>
            <a:lvl9pPr marL="5201839" indent="0" algn="ctr">
              <a:buNone/>
              <a:defRPr sz="2276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DBBDC02-C0C3-4684-9649-9E77B27B9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36A47F9-A58D-46C1-87C2-1EC1439E29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D433D59-E98A-4B48-AC89-A7BCDADB1F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616733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A423842-F551-4D80-871F-D56BD6D24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30A35C6B-3957-455F-A0F9-443723A43C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42B9892-8727-4754-B647-A492146F2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8E612E0-5302-477B-B07D-D24852BE3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8CC5AAC-4BB6-47C1-BF82-507BE1D5D6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95552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FFE09DB6-516F-44D9-83C3-F1DCBE947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2409126" y="519289"/>
            <a:ext cx="3738994" cy="82657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2309E6F-0725-4384-B705-CEF2963487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192143" y="519289"/>
            <a:ext cx="11000229" cy="82657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D1B0A9F-DC9D-4DAC-9A49-1908F33189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D027A55-FAEA-4457-BBC1-C3A7E9DB5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FA6359F-9A72-4BAF-97FD-414BFCEBF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679426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EEC343F-4FD3-4C09-B346-912D2354C3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>
            <a:lvl1pPr>
              <a:defRPr sz="4551">
                <a:latin typeface="Verdana Pro Light" panose="020B0304030504040204" pitchFamily="34" charset="0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EFC7927-5CF0-49C2-89EC-D757C843FA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Verdana Pro Light" panose="020B0304030504040204" pitchFamily="34" charset="0"/>
              </a:defRPr>
            </a:lvl1pPr>
            <a:lvl2pPr>
              <a:defRPr>
                <a:latin typeface="Verdana Pro Light" panose="020B0304030504040204" pitchFamily="34" charset="0"/>
              </a:defRPr>
            </a:lvl2pPr>
            <a:lvl3pPr>
              <a:defRPr>
                <a:latin typeface="Verdana Pro Light" panose="020B0304030504040204" pitchFamily="34" charset="0"/>
              </a:defRPr>
            </a:lvl3pPr>
            <a:lvl4pPr>
              <a:defRPr>
                <a:latin typeface="Verdana Pro Light" panose="020B0304030504040204" pitchFamily="34" charset="0"/>
              </a:defRPr>
            </a:lvl4pPr>
            <a:lvl5pPr>
              <a:defRPr>
                <a:latin typeface="Verdana Pro Light" panose="020B030403050404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116DE62-4089-44B3-8490-C823B5995D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3B05F-1EEA-40FC-8B52-5D91943D26B5}" type="datetimeFigureOut">
              <a:rPr lang="en-CA" smtClean="0"/>
              <a:t>2020-10-3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EB23FB5-D855-4AC7-A3AE-4362B8434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6FC3E87-DEEE-4231-A30A-BFFD607886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E3656-A904-429E-9F74-CBC9A86DD2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96236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413D268-42FA-4FEC-9439-CB82C61D1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83112" y="2431628"/>
            <a:ext cx="14955977" cy="4057226"/>
          </a:xfrm>
        </p:spPr>
        <p:txBody>
          <a:bodyPr anchor="b"/>
          <a:lstStyle>
            <a:lvl1pPr>
              <a:defRPr sz="853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BBD084D-507F-4C40-B5FA-8C5E82A1E0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83112" y="6527237"/>
            <a:ext cx="14955977" cy="2133599"/>
          </a:xfrm>
        </p:spPr>
        <p:txBody>
          <a:bodyPr/>
          <a:lstStyle>
            <a:lvl1pPr marL="0" indent="0">
              <a:buNone/>
              <a:defRPr sz="3413">
                <a:solidFill>
                  <a:schemeClr val="tx1">
                    <a:tint val="75000"/>
                  </a:schemeClr>
                </a:solidFill>
              </a:defRPr>
            </a:lvl1pPr>
            <a:lvl2pPr marL="6502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2pPr>
            <a:lvl3pPr marL="1300460" indent="0">
              <a:buNone/>
              <a:defRPr sz="2560">
                <a:solidFill>
                  <a:schemeClr val="tx1">
                    <a:tint val="75000"/>
                  </a:schemeClr>
                </a:solidFill>
              </a:defRPr>
            </a:lvl3pPr>
            <a:lvl4pPr marL="1950690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4pPr>
            <a:lvl5pPr marL="260091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5pPr>
            <a:lvl6pPr marL="325114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6pPr>
            <a:lvl7pPr marL="390137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7pPr>
            <a:lvl8pPr marL="455160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8pPr>
            <a:lvl9pPr marL="5201839" indent="0">
              <a:buNone/>
              <a:defRPr sz="227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8A772E9-DD74-4F8A-B683-B8662708B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56A334-F9E7-4372-AE23-56EB39D002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881D483-245E-4B55-BAEB-353C327D0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607431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8037BFE-4C9C-4D03-B45E-CBAE6F137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AE95AA-1301-44B7-855F-68B165F6CE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192143" y="2596444"/>
            <a:ext cx="7369612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8F6CB99-EBD2-41C4-BFC2-873BF992C8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778508" y="2596444"/>
            <a:ext cx="7369612" cy="61885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6A9ECB4-2F34-42FC-A7BF-E20EAD5E4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ECB3B4B-2CB0-444F-A7D0-D6597D2D0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7603DCC-13EA-4AD6-87A3-54EA8BFE3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0936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D15A830-0319-473F-826B-15BDC8642C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519290"/>
            <a:ext cx="14955977" cy="188524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94A3E32-0B12-4A46-8861-3F02731DB3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94403" y="2390987"/>
            <a:ext cx="7335743" cy="1171786"/>
          </a:xfrm>
        </p:spPr>
        <p:txBody>
          <a:bodyPr anchor="b"/>
          <a:lstStyle>
            <a:lvl1pPr marL="0" indent="0">
              <a:buNone/>
              <a:defRPr sz="3413" b="1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894AA4E-12A0-4A6D-8877-45A8ED1DEF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194403" y="3562773"/>
            <a:ext cx="7335743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B41F7D0E-9E2B-4E81-BD6D-AECBD4A2CD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8778508" y="2390987"/>
            <a:ext cx="7371870" cy="1171786"/>
          </a:xfrm>
        </p:spPr>
        <p:txBody>
          <a:bodyPr anchor="b"/>
          <a:lstStyle>
            <a:lvl1pPr marL="0" indent="0">
              <a:buNone/>
              <a:defRPr sz="3413" b="1"/>
            </a:lvl1pPr>
            <a:lvl2pPr marL="650230" indent="0">
              <a:buNone/>
              <a:defRPr sz="2844" b="1"/>
            </a:lvl2pPr>
            <a:lvl3pPr marL="1300460" indent="0">
              <a:buNone/>
              <a:defRPr sz="2560" b="1"/>
            </a:lvl3pPr>
            <a:lvl4pPr marL="1950690" indent="0">
              <a:buNone/>
              <a:defRPr sz="2276" b="1"/>
            </a:lvl4pPr>
            <a:lvl5pPr marL="2600919" indent="0">
              <a:buNone/>
              <a:defRPr sz="2276" b="1"/>
            </a:lvl5pPr>
            <a:lvl6pPr marL="3251149" indent="0">
              <a:buNone/>
              <a:defRPr sz="2276" b="1"/>
            </a:lvl6pPr>
            <a:lvl7pPr marL="3901379" indent="0">
              <a:buNone/>
              <a:defRPr sz="2276" b="1"/>
            </a:lvl7pPr>
            <a:lvl8pPr marL="4551609" indent="0">
              <a:buNone/>
              <a:defRPr sz="2276" b="1"/>
            </a:lvl8pPr>
            <a:lvl9pPr marL="5201839" indent="0">
              <a:buNone/>
              <a:defRPr sz="227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A40A577A-1011-42B6-9453-33169D1A76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8778508" y="3562773"/>
            <a:ext cx="7371870" cy="52403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2763C44-2CE1-4237-9B7A-A2EFE16F8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76DBD197-3CD3-4D1D-B63E-398146582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AABF5D96-0119-4BEA-81A3-ABA460A54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5915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6D97460-5C3A-4131-A05F-7DC1FA2FD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AAE6CAE5-2966-4106-BF8B-60DB7D9CBA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63B05F-1EEA-40FC-8B52-5D91943D26B5}" type="datetimeFigureOut">
              <a:rPr lang="en-CA" smtClean="0"/>
              <a:t>2020-10-3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318A445A-2054-42F4-8A86-2611F5A8B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DDE6ED77-F5C1-4406-8DDE-73B6B08CB3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E3656-A904-429E-9F74-CBC9A86DD20F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7282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E547DDC8-62EA-4321-A529-43D75C3A23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6548B9E1-E8C5-40F2-B144-9A46474C51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3CDBDA6D-0FE5-4D04-BFA2-372055A47C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70183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D921289-55BF-4C6C-837C-21FC5E6F62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650240"/>
            <a:ext cx="5592686" cy="2275840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CD1B8BD-1CAB-4D22-B31A-2039E3413B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7371870" y="1404338"/>
            <a:ext cx="8778508" cy="6931378"/>
          </a:xfrm>
        </p:spPr>
        <p:txBody>
          <a:bodyPr/>
          <a:lstStyle>
            <a:lvl1pPr>
              <a:defRPr sz="4551"/>
            </a:lvl1pPr>
            <a:lvl2pPr>
              <a:defRPr sz="3982"/>
            </a:lvl2pPr>
            <a:lvl3pPr>
              <a:defRPr sz="3413"/>
            </a:lvl3pPr>
            <a:lvl4pPr>
              <a:defRPr sz="2844"/>
            </a:lvl4pPr>
            <a:lvl5pPr>
              <a:defRPr sz="2844"/>
            </a:lvl5pPr>
            <a:lvl6pPr>
              <a:defRPr sz="2844"/>
            </a:lvl6pPr>
            <a:lvl7pPr>
              <a:defRPr sz="2844"/>
            </a:lvl7pPr>
            <a:lvl8pPr>
              <a:defRPr sz="2844"/>
            </a:lvl8pPr>
            <a:lvl9pPr>
              <a:defRPr sz="284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CE9F0F7-EAA3-4C72-9847-227CC655A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94402" y="2926080"/>
            <a:ext cx="5592686" cy="5420925"/>
          </a:xfrm>
        </p:spPr>
        <p:txBody>
          <a:bodyPr/>
          <a:lstStyle>
            <a:lvl1pPr marL="0" indent="0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52B13FD-18CA-4FF9-A785-EF2AE3059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D1B2762-020D-4406-BC48-65A102AEDD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58A64C5-E918-4094-876E-8B1535F32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86907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4B4B98D-1D14-49E7-8438-CFB73D2D2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4402" y="650240"/>
            <a:ext cx="5592686" cy="2275840"/>
          </a:xfrm>
        </p:spPr>
        <p:txBody>
          <a:bodyPr anchor="b"/>
          <a:lstStyle>
            <a:lvl1pPr>
              <a:defRPr sz="455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A994C05B-DAD6-4325-84DD-7FF78966F7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7371870" y="1404338"/>
            <a:ext cx="8778508" cy="6931378"/>
          </a:xfrm>
        </p:spPr>
        <p:txBody>
          <a:bodyPr/>
          <a:lstStyle>
            <a:lvl1pPr marL="0" indent="0">
              <a:buNone/>
              <a:defRPr sz="4551"/>
            </a:lvl1pPr>
            <a:lvl2pPr marL="650230" indent="0">
              <a:buNone/>
              <a:defRPr sz="3982"/>
            </a:lvl2pPr>
            <a:lvl3pPr marL="1300460" indent="0">
              <a:buNone/>
              <a:defRPr sz="3413"/>
            </a:lvl3pPr>
            <a:lvl4pPr marL="1950690" indent="0">
              <a:buNone/>
              <a:defRPr sz="2844"/>
            </a:lvl4pPr>
            <a:lvl5pPr marL="2600919" indent="0">
              <a:buNone/>
              <a:defRPr sz="2844"/>
            </a:lvl5pPr>
            <a:lvl6pPr marL="3251149" indent="0">
              <a:buNone/>
              <a:defRPr sz="2844"/>
            </a:lvl6pPr>
            <a:lvl7pPr marL="3901379" indent="0">
              <a:buNone/>
              <a:defRPr sz="2844"/>
            </a:lvl7pPr>
            <a:lvl8pPr marL="4551609" indent="0">
              <a:buNone/>
              <a:defRPr sz="2844"/>
            </a:lvl8pPr>
            <a:lvl9pPr marL="5201839" indent="0">
              <a:buNone/>
              <a:defRPr sz="2844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CB3FA1A-6732-47D0-A1FC-1AC2EC4E1A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94402" y="2926080"/>
            <a:ext cx="5592686" cy="5420925"/>
          </a:xfrm>
        </p:spPr>
        <p:txBody>
          <a:bodyPr/>
          <a:lstStyle>
            <a:lvl1pPr marL="0" indent="0">
              <a:buNone/>
              <a:defRPr sz="2276"/>
            </a:lvl1pPr>
            <a:lvl2pPr marL="650230" indent="0">
              <a:buNone/>
              <a:defRPr sz="1991"/>
            </a:lvl2pPr>
            <a:lvl3pPr marL="1300460" indent="0">
              <a:buNone/>
              <a:defRPr sz="1707"/>
            </a:lvl3pPr>
            <a:lvl4pPr marL="1950690" indent="0">
              <a:buNone/>
              <a:defRPr sz="1422"/>
            </a:lvl4pPr>
            <a:lvl5pPr marL="2600919" indent="0">
              <a:buNone/>
              <a:defRPr sz="1422"/>
            </a:lvl5pPr>
            <a:lvl6pPr marL="3251149" indent="0">
              <a:buNone/>
              <a:defRPr sz="1422"/>
            </a:lvl6pPr>
            <a:lvl7pPr marL="3901379" indent="0">
              <a:buNone/>
              <a:defRPr sz="1422"/>
            </a:lvl7pPr>
            <a:lvl8pPr marL="4551609" indent="0">
              <a:buNone/>
              <a:defRPr sz="1422"/>
            </a:lvl8pPr>
            <a:lvl9pPr marL="5201839" indent="0">
              <a:buNone/>
              <a:defRPr sz="142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BC89873-7DDF-4346-A850-51CA87FD1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28AE4AB-3EC0-4721-8B67-B866CD111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52D4242-3FD2-4E4B-8102-F4A75DCE4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771827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966BAED-E4B6-4562-BC97-BEFD3E9BCF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92143" y="519290"/>
            <a:ext cx="14955977" cy="188524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9EF524F-0190-4BD0-9773-491B3FD9D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192143" y="2596444"/>
            <a:ext cx="14955977" cy="61885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682D897-74AC-483A-9CCB-60517599A5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192143" y="9040143"/>
            <a:ext cx="390155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F8FC3-3BE3-49D3-97D0-543DDF688B5C}" type="datetimeFigureOut">
              <a:rPr lang="en-US" smtClean="0"/>
              <a:t>10/30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2BB87F-B422-4217-9444-0EAA5E4A23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743962" y="9040143"/>
            <a:ext cx="585233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4AD5CBD-3578-472D-9511-DB4596DE44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2246561" y="9040143"/>
            <a:ext cx="3901559" cy="51928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B4B4D-7CA3-9044-876B-883B54F8677D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363052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4" r:id="rId1"/>
    <p:sldLayoutId id="2147483665" r:id="rId2"/>
    <p:sldLayoutId id="2147483666" r:id="rId3"/>
    <p:sldLayoutId id="2147483667" r:id="rId4"/>
    <p:sldLayoutId id="2147483668" r:id="rId5"/>
    <p:sldLayoutId id="2147483669" r:id="rId6"/>
    <p:sldLayoutId id="2147483670" r:id="rId7"/>
    <p:sldLayoutId id="2147483671" r:id="rId8"/>
    <p:sldLayoutId id="2147483672" r:id="rId9"/>
    <p:sldLayoutId id="2147483673" r:id="rId10"/>
    <p:sldLayoutId id="2147483674" r:id="rId11"/>
  </p:sldLayoutIdLst>
  <p:txStyles>
    <p:titleStyle>
      <a:lvl1pPr algn="l" defTabSz="1300460" rtl="0" eaLnBrk="1" latinLnBrk="0" hangingPunct="1">
        <a:lnSpc>
          <a:spcPct val="90000"/>
        </a:lnSpc>
        <a:spcBef>
          <a:spcPct val="0"/>
        </a:spcBef>
        <a:buNone/>
        <a:defRPr sz="62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5115" indent="-325115" algn="l" defTabSz="1300460" rtl="0" eaLnBrk="1" latinLnBrk="0" hangingPunct="1">
        <a:lnSpc>
          <a:spcPct val="90000"/>
        </a:lnSpc>
        <a:spcBef>
          <a:spcPts val="1422"/>
        </a:spcBef>
        <a:buFont typeface="Arial" panose="020B0604020202020204" pitchFamily="34" charset="0"/>
        <a:buChar char="•"/>
        <a:defRPr sz="3982" kern="1200">
          <a:solidFill>
            <a:schemeClr val="tx1"/>
          </a:solidFill>
          <a:latin typeface="+mn-lt"/>
          <a:ea typeface="+mn-ea"/>
          <a:cs typeface="+mn-cs"/>
        </a:defRPr>
      </a:lvl1pPr>
      <a:lvl2pPr marL="975345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3413" kern="1200">
          <a:solidFill>
            <a:schemeClr val="tx1"/>
          </a:solidFill>
          <a:latin typeface="+mn-lt"/>
          <a:ea typeface="+mn-ea"/>
          <a:cs typeface="+mn-cs"/>
        </a:defRPr>
      </a:lvl2pPr>
      <a:lvl3pPr marL="1625575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844" kern="1200">
          <a:solidFill>
            <a:schemeClr val="tx1"/>
          </a:solidFill>
          <a:latin typeface="+mn-lt"/>
          <a:ea typeface="+mn-ea"/>
          <a:cs typeface="+mn-cs"/>
        </a:defRPr>
      </a:lvl3pPr>
      <a:lvl4pPr marL="227580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92603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57626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422649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87672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526954" indent="-325115" algn="l" defTabSz="1300460" rtl="0" eaLnBrk="1" latinLnBrk="0" hangingPunct="1">
        <a:lnSpc>
          <a:spcPct val="90000"/>
        </a:lnSpc>
        <a:spcBef>
          <a:spcPts val="711"/>
        </a:spcBef>
        <a:buFont typeface="Arial" panose="020B0604020202020204" pitchFamily="34" charset="0"/>
        <a:buChar char="•"/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1pPr>
      <a:lvl2pPr marL="65023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2pPr>
      <a:lvl3pPr marL="130046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3pPr>
      <a:lvl4pPr marL="1950690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4pPr>
      <a:lvl5pPr marL="260091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5pPr>
      <a:lvl6pPr marL="325114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6pPr>
      <a:lvl7pPr marL="390137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7pPr>
      <a:lvl8pPr marL="455160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8pPr>
      <a:lvl9pPr marL="5201839" algn="l" defTabSz="1300460" rtl="0" eaLnBrk="1" latinLnBrk="0" hangingPunct="1">
        <a:defRPr sz="25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4" Type="http://schemas.openxmlformats.org/officeDocument/2006/relationships/image" Target="../media/image3.pn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F43CF1D4-7731-435F-83B0-6C51B0807759}"/>
              </a:ext>
            </a:extLst>
          </p:cNvPr>
          <p:cNvSpPr txBox="1"/>
          <p:nvPr/>
        </p:nvSpPr>
        <p:spPr>
          <a:xfrm>
            <a:off x="1544147" y="8498108"/>
            <a:ext cx="15378546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600" b="1" dirty="0">
                <a:latin typeface="Verdana" charset="0"/>
                <a:ea typeface="Verdana" charset="0"/>
                <a:cs typeface="Verdana" charset="0"/>
              </a:rPr>
              <a:t>Supplementary </a:t>
            </a:r>
            <a:r>
              <a:rPr lang="en-CA" sz="1600" b="1">
                <a:latin typeface="Verdana" charset="0"/>
                <a:ea typeface="Verdana" charset="0"/>
                <a:cs typeface="Verdana" charset="0"/>
              </a:rPr>
              <a:t>Figure </a:t>
            </a:r>
            <a:r>
              <a:rPr lang="en-CA" sz="1600" b="1" smtClean="0">
                <a:latin typeface="Verdana" charset="0"/>
                <a:ea typeface="Verdana" charset="0"/>
                <a:cs typeface="Verdana" charset="0"/>
              </a:rPr>
              <a:t>S3</a:t>
            </a:r>
            <a:r>
              <a:rPr lang="en-CA" sz="1600" b="1" dirty="0" smtClean="0">
                <a:latin typeface="Verdana" charset="0"/>
                <a:ea typeface="Verdana" charset="0"/>
                <a:cs typeface="Verdana" charset="0"/>
              </a:rPr>
              <a:t>.</a:t>
            </a:r>
            <a:r>
              <a:rPr lang="en-CA" sz="1600" dirty="0" smtClean="0">
                <a:latin typeface="Verdana" charset="0"/>
                <a:ea typeface="Verdana" charset="0"/>
                <a:cs typeface="Verdana" charset="0"/>
              </a:rPr>
              <a:t> Four 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day time-course examining </a:t>
            </a:r>
            <a:r>
              <a:rPr lang="en-CA" sz="1600" dirty="0" smtClean="0">
                <a:latin typeface="Verdana" charset="0"/>
                <a:ea typeface="Verdana" charset="0"/>
                <a:cs typeface="Verdana" charset="0"/>
              </a:rPr>
              <a:t>the effects 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of AZD-8055 on pAKT (S-473) levels </a:t>
            </a:r>
            <a:r>
              <a:rPr lang="en-CA" sz="1600" dirty="0" smtClean="0">
                <a:latin typeface="Verdana" charset="0"/>
                <a:ea typeface="Verdana" charset="0"/>
                <a:cs typeface="Verdana" charset="0"/>
              </a:rPr>
              <a:t>on 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105C </a:t>
            </a:r>
            <a:r>
              <a:rPr lang="en-CA" sz="1600" dirty="0" smtClean="0">
                <a:latin typeface="Verdana" charset="0"/>
                <a:ea typeface="Verdana" charset="0"/>
                <a:cs typeface="Verdana" charset="0"/>
              </a:rPr>
              <a:t>monolayer cultures. The 105C 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cell line was seeded at a density of  500,000 cells per plate in </a:t>
            </a:r>
            <a:r>
              <a:rPr lang="en-CA" sz="1600" dirty="0" smtClean="0">
                <a:latin typeface="Verdana" charset="0"/>
                <a:ea typeface="Verdana" charset="0"/>
                <a:cs typeface="Verdana" charset="0"/>
              </a:rPr>
              <a:t>10cm dishes,  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2 days after </a:t>
            </a:r>
            <a:r>
              <a:rPr lang="en-CA" sz="1600" dirty="0" smtClean="0">
                <a:latin typeface="Verdana" charset="0"/>
                <a:ea typeface="Verdana" charset="0"/>
                <a:cs typeface="Verdana" charset="0"/>
              </a:rPr>
              <a:t>seeding, </a:t>
            </a:r>
            <a:r>
              <a:rPr lang="en-CA" sz="1600" dirty="0">
                <a:latin typeface="Verdana" charset="0"/>
                <a:ea typeface="Verdana" charset="0"/>
                <a:cs typeface="Verdana" charset="0"/>
              </a:rPr>
              <a:t>cells were treated with a single dose of AZD-8055 at the concentration indicated, then WCE was harvested at 24h intervals, up to day 4 and subjected to western blot to assess pAKT (S-473) levels.  We observe a consistent and significant reduction in pAKT (S-473) levels at the 105C cell line IC50 over 4 days and a complete loss of detectable AKT (S-473) a 1 µM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BA9570B3-8D77-4620-9BC3-3C863364C0D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54364" y="7161639"/>
            <a:ext cx="5415863" cy="64427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BD6C3ADA-0C1C-4195-A479-BB2AF1F6D1C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54368" y="5412729"/>
            <a:ext cx="5415862" cy="86506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96903027-B1CD-44BB-9B8A-D600DD13C8E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99678" y="5413997"/>
            <a:ext cx="2596983" cy="863797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AF6BE1D1-D5F3-42C8-81F0-B2E13DCB0C3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99678" y="7161639"/>
            <a:ext cx="2596983" cy="64427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18CAD3D-E3C8-4312-A24C-09C1A6FBD7EC}"/>
              </a:ext>
            </a:extLst>
          </p:cNvPr>
          <p:cNvSpPr txBox="1"/>
          <p:nvPr/>
        </p:nvSpPr>
        <p:spPr>
          <a:xfrm>
            <a:off x="2889315" y="7830084"/>
            <a:ext cx="7509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DAY: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E633B86B-2D12-4DCA-B7E1-5215F60795D8}"/>
              </a:ext>
            </a:extLst>
          </p:cNvPr>
          <p:cNvSpPr txBox="1"/>
          <p:nvPr/>
        </p:nvSpPr>
        <p:spPr>
          <a:xfrm>
            <a:off x="4367285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5BFE48B3-2440-43E8-A778-4F59665E2E96}"/>
              </a:ext>
            </a:extLst>
          </p:cNvPr>
          <p:cNvSpPr txBox="1"/>
          <p:nvPr/>
        </p:nvSpPr>
        <p:spPr>
          <a:xfrm>
            <a:off x="4980406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8A6A2BA6-884C-46D2-B604-08E0FCEC6F57}"/>
              </a:ext>
            </a:extLst>
          </p:cNvPr>
          <p:cNvSpPr txBox="1"/>
          <p:nvPr/>
        </p:nvSpPr>
        <p:spPr>
          <a:xfrm>
            <a:off x="5593528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CE7E661D-3295-43D0-8734-D0070FD14F77}"/>
              </a:ext>
            </a:extLst>
          </p:cNvPr>
          <p:cNvSpPr txBox="1"/>
          <p:nvPr/>
        </p:nvSpPr>
        <p:spPr>
          <a:xfrm>
            <a:off x="6206649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5CC991CF-4EB6-485D-9CD5-F235F9325FE6}"/>
              </a:ext>
            </a:extLst>
          </p:cNvPr>
          <p:cNvSpPr txBox="1"/>
          <p:nvPr/>
        </p:nvSpPr>
        <p:spPr>
          <a:xfrm>
            <a:off x="7341820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1180D03B-42B0-477D-A4C0-23B949D9F04F}"/>
              </a:ext>
            </a:extLst>
          </p:cNvPr>
          <p:cNvSpPr txBox="1"/>
          <p:nvPr/>
        </p:nvSpPr>
        <p:spPr>
          <a:xfrm>
            <a:off x="7954941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D1E37094-7DE8-4914-B014-B7CA87620847}"/>
              </a:ext>
            </a:extLst>
          </p:cNvPr>
          <p:cNvSpPr txBox="1"/>
          <p:nvPr/>
        </p:nvSpPr>
        <p:spPr>
          <a:xfrm>
            <a:off x="8568063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9EB99C91-0CE3-4ABC-AEA4-9CF4FF3F816C}"/>
              </a:ext>
            </a:extLst>
          </p:cNvPr>
          <p:cNvSpPr txBox="1"/>
          <p:nvPr/>
        </p:nvSpPr>
        <p:spPr>
          <a:xfrm>
            <a:off x="9069753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2A09BE9-8CF2-4756-8343-B57BD47F3867}"/>
              </a:ext>
            </a:extLst>
          </p:cNvPr>
          <p:cNvSpPr txBox="1"/>
          <p:nvPr/>
        </p:nvSpPr>
        <p:spPr>
          <a:xfrm>
            <a:off x="9787139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D5CEC6A4-E7FA-452D-AF98-3E041C89877A}"/>
              </a:ext>
            </a:extLst>
          </p:cNvPr>
          <p:cNvSpPr txBox="1"/>
          <p:nvPr/>
        </p:nvSpPr>
        <p:spPr>
          <a:xfrm>
            <a:off x="10400260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1B9B2A37-3BB0-4F3F-A47F-369084D6A963}"/>
              </a:ext>
            </a:extLst>
          </p:cNvPr>
          <p:cNvSpPr txBox="1"/>
          <p:nvPr/>
        </p:nvSpPr>
        <p:spPr>
          <a:xfrm>
            <a:off x="11013382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896746B6-18C5-44FA-901F-F1FD728D464A}"/>
              </a:ext>
            </a:extLst>
          </p:cNvPr>
          <p:cNvSpPr txBox="1"/>
          <p:nvPr/>
        </p:nvSpPr>
        <p:spPr>
          <a:xfrm>
            <a:off x="11626503" y="7830790"/>
            <a:ext cx="327334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CDF0AB74-1BDF-4A7A-858A-4E0E851E8F92}"/>
              </a:ext>
            </a:extLst>
          </p:cNvPr>
          <p:cNvSpPr txBox="1"/>
          <p:nvPr/>
        </p:nvSpPr>
        <p:spPr>
          <a:xfrm>
            <a:off x="12371473" y="7211540"/>
            <a:ext cx="12595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BDAC1289-BAD8-4E36-BB45-C8F58F1080D8}"/>
              </a:ext>
            </a:extLst>
          </p:cNvPr>
          <p:cNvSpPr txBox="1"/>
          <p:nvPr/>
        </p:nvSpPr>
        <p:spPr>
          <a:xfrm>
            <a:off x="12371473" y="5584688"/>
            <a:ext cx="20610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pAKT (S-473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173354B0-64C7-482F-83BB-A3F156521E1E}"/>
              </a:ext>
            </a:extLst>
          </p:cNvPr>
          <p:cNvSpPr txBox="1"/>
          <p:nvPr/>
        </p:nvSpPr>
        <p:spPr>
          <a:xfrm>
            <a:off x="12371473" y="5060926"/>
            <a:ext cx="12538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defRPr>
            </a:lvl1pPr>
          </a:lstStyle>
          <a:p>
            <a:r>
              <a:rPr lang="en-CA" sz="2000" dirty="0"/>
              <a:t>Antibody: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946698D5-21D2-49C0-B6CA-B328CE2D18B1}"/>
              </a:ext>
            </a:extLst>
          </p:cNvPr>
          <p:cNvSpPr txBox="1"/>
          <p:nvPr/>
        </p:nvSpPr>
        <p:spPr>
          <a:xfrm>
            <a:off x="4809971" y="4600602"/>
            <a:ext cx="1008609" cy="3986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E47F974B-B545-4C75-907E-349F317592BD}"/>
              </a:ext>
            </a:extLst>
          </p:cNvPr>
          <p:cNvSpPr txBox="1"/>
          <p:nvPr/>
        </p:nvSpPr>
        <p:spPr>
          <a:xfrm>
            <a:off x="7014218" y="4523983"/>
            <a:ext cx="266290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8.18 nM (AZD-8055)</a:t>
            </a:r>
          </a:p>
          <a:p>
            <a:pPr algn="ctr"/>
            <a:r>
              <a:rPr lang="en-CA" sz="16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(IC</a:t>
            </a:r>
            <a:r>
              <a:rPr lang="en-CA" sz="16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0</a:t>
            </a:r>
            <a:r>
              <a:rPr lang="en-CA" sz="16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 105C Monolayer)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xmlns="" id="{65FD485F-55C7-4984-BF4D-0FCBC52073FF}"/>
              </a:ext>
            </a:extLst>
          </p:cNvPr>
          <p:cNvSpPr/>
          <p:nvPr/>
        </p:nvSpPr>
        <p:spPr>
          <a:xfrm>
            <a:off x="9847903" y="4504092"/>
            <a:ext cx="2164375" cy="3986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 µM (AZD-8055)</a:t>
            </a:r>
          </a:p>
        </p:txBody>
      </p:sp>
      <p:sp>
        <p:nvSpPr>
          <p:cNvPr id="35" name="Right Bracket 34">
            <a:extLst>
              <a:ext uri="{FF2B5EF4-FFF2-40B4-BE49-F238E27FC236}">
                <a16:creationId xmlns:a16="http://schemas.microsoft.com/office/drawing/2014/main" xmlns="" id="{AF3D3D4D-9745-470E-BF83-EF342CB527FB}"/>
              </a:ext>
            </a:extLst>
          </p:cNvPr>
          <p:cNvSpPr/>
          <p:nvPr/>
        </p:nvSpPr>
        <p:spPr>
          <a:xfrm rot="16200000">
            <a:off x="5317665" y="4085303"/>
            <a:ext cx="74974" cy="2401566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20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2B1F4911-2202-4CB8-BA9F-DAE0AC18271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54368" y="6305780"/>
            <a:ext cx="5415862" cy="81529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60408577-46DA-46B8-912D-762287C89DC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99678" y="6305780"/>
            <a:ext cx="2596983" cy="815296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6E97801C-06B5-438C-B5B2-28E22CA3E0A6}"/>
              </a:ext>
            </a:extLst>
          </p:cNvPr>
          <p:cNvSpPr txBox="1"/>
          <p:nvPr/>
        </p:nvSpPr>
        <p:spPr>
          <a:xfrm>
            <a:off x="12371473" y="6310600"/>
            <a:ext cx="15009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24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Total AKT</a:t>
            </a:r>
          </a:p>
        </p:txBody>
      </p:sp>
      <p:sp>
        <p:nvSpPr>
          <p:cNvPr id="42" name="Right Bracket 41">
            <a:extLst>
              <a:ext uri="{FF2B5EF4-FFF2-40B4-BE49-F238E27FC236}">
                <a16:creationId xmlns:a16="http://schemas.microsoft.com/office/drawing/2014/main" xmlns="" id="{AD72FCE9-5002-4F30-8800-D1F22E4942A2}"/>
              </a:ext>
            </a:extLst>
          </p:cNvPr>
          <p:cNvSpPr/>
          <p:nvPr/>
        </p:nvSpPr>
        <p:spPr>
          <a:xfrm rot="16200000">
            <a:off x="10812293" y="4078491"/>
            <a:ext cx="74974" cy="2401566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20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43" name="Right Bracket 42">
            <a:extLst>
              <a:ext uri="{FF2B5EF4-FFF2-40B4-BE49-F238E27FC236}">
                <a16:creationId xmlns:a16="http://schemas.microsoft.com/office/drawing/2014/main" xmlns="" id="{69044C1E-A360-4D78-9C42-5A2D3E7598AE}"/>
              </a:ext>
            </a:extLst>
          </p:cNvPr>
          <p:cNvSpPr/>
          <p:nvPr/>
        </p:nvSpPr>
        <p:spPr>
          <a:xfrm rot="16200000">
            <a:off x="8308183" y="4085304"/>
            <a:ext cx="74974" cy="2401566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20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xmlns="" id="{DDDBF279-D3CD-470C-B5F9-0215BF864547}"/>
              </a:ext>
            </a:extLst>
          </p:cNvPr>
          <p:cNvCxnSpPr/>
          <p:nvPr/>
        </p:nvCxnSpPr>
        <p:spPr>
          <a:xfrm>
            <a:off x="2214811" y="1868975"/>
            <a:ext cx="11007013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 75">
            <a:extLst>
              <a:ext uri="{FF2B5EF4-FFF2-40B4-BE49-F238E27FC236}">
                <a16:creationId xmlns:a16="http://schemas.microsoft.com/office/drawing/2014/main" xmlns="" id="{9A7412ED-2519-41F0-8149-BE8D93E220AA}"/>
              </a:ext>
            </a:extLst>
          </p:cNvPr>
          <p:cNvSpPr/>
          <p:nvPr/>
        </p:nvSpPr>
        <p:spPr>
          <a:xfrm>
            <a:off x="2099117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xmlns="" id="{575DDC65-E0E7-4336-A351-DDBE372012AE}"/>
              </a:ext>
            </a:extLst>
          </p:cNvPr>
          <p:cNvCxnSpPr>
            <a:cxnSpLocks/>
            <a:stCxn id="76" idx="0"/>
          </p:cNvCxnSpPr>
          <p:nvPr/>
        </p:nvCxnSpPr>
        <p:spPr>
          <a:xfrm flipV="1">
            <a:off x="2302746" y="517055"/>
            <a:ext cx="0" cy="11245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EF434FAA-DDB3-4228-8F7A-9DA84A9CE1F2}"/>
              </a:ext>
            </a:extLst>
          </p:cNvPr>
          <p:cNvSpPr txBox="1"/>
          <p:nvPr/>
        </p:nvSpPr>
        <p:spPr>
          <a:xfrm>
            <a:off x="1600140" y="72442"/>
            <a:ext cx="1669047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Cells seeded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xmlns="" id="{30AB81C3-2530-498D-A3E6-4F67DC4A0C7E}"/>
              </a:ext>
            </a:extLst>
          </p:cNvPr>
          <p:cNvSpPr/>
          <p:nvPr/>
        </p:nvSpPr>
        <p:spPr>
          <a:xfrm>
            <a:off x="3635407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xmlns="" id="{07A35AC7-B490-426D-9A6C-0B126457AE40}"/>
              </a:ext>
            </a:extLst>
          </p:cNvPr>
          <p:cNvSpPr/>
          <p:nvPr/>
        </p:nvSpPr>
        <p:spPr>
          <a:xfrm>
            <a:off x="5171697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</a:t>
            </a:r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xmlns="" id="{5AFC0AB4-8E06-448A-A61D-DCB13D450808}"/>
              </a:ext>
            </a:extLst>
          </p:cNvPr>
          <p:cNvCxnSpPr>
            <a:cxnSpLocks/>
          </p:cNvCxnSpPr>
          <p:nvPr/>
        </p:nvCxnSpPr>
        <p:spPr>
          <a:xfrm flipV="1">
            <a:off x="5375326" y="517055"/>
            <a:ext cx="0" cy="11245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xmlns="" id="{FDBE1B9C-8543-4657-891D-ACA932D1CD3D}"/>
              </a:ext>
            </a:extLst>
          </p:cNvPr>
          <p:cNvSpPr txBox="1"/>
          <p:nvPr/>
        </p:nvSpPr>
        <p:spPr>
          <a:xfrm>
            <a:off x="3910315" y="56948"/>
            <a:ext cx="2989215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Treatment (0/IC</a:t>
            </a:r>
            <a:r>
              <a:rPr lang="en-CA" sz="20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0</a:t>
            </a:r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/1uM)</a:t>
            </a:r>
            <a:endParaRPr lang="en-CA" sz="2000" baseline="-250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xmlns="" id="{8D2AB2BD-3593-43FC-BA2E-36B16AA4B010}"/>
              </a:ext>
            </a:extLst>
          </p:cNvPr>
          <p:cNvSpPr/>
          <p:nvPr/>
        </p:nvSpPr>
        <p:spPr>
          <a:xfrm>
            <a:off x="6707987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xmlns="" id="{AD4A8594-F587-44EF-B39B-0B44F113496C}"/>
              </a:ext>
            </a:extLst>
          </p:cNvPr>
          <p:cNvSpPr/>
          <p:nvPr/>
        </p:nvSpPr>
        <p:spPr>
          <a:xfrm>
            <a:off x="8244277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xmlns="" id="{4F8F2EC9-0A18-4EBD-B9BC-FEC89E354223}"/>
              </a:ext>
            </a:extLst>
          </p:cNvPr>
          <p:cNvSpPr/>
          <p:nvPr/>
        </p:nvSpPr>
        <p:spPr>
          <a:xfrm>
            <a:off x="9780568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xmlns="" id="{00CB5D57-05A6-443D-B01F-0A962CF6895B}"/>
              </a:ext>
            </a:extLst>
          </p:cNvPr>
          <p:cNvCxnSpPr>
            <a:cxnSpLocks/>
            <a:stCxn id="85" idx="0"/>
          </p:cNvCxnSpPr>
          <p:nvPr/>
        </p:nvCxnSpPr>
        <p:spPr>
          <a:xfrm flipV="1">
            <a:off x="9984197" y="517055"/>
            <a:ext cx="0" cy="11245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352FC8C3-3378-484A-8265-03E310726701}"/>
              </a:ext>
            </a:extLst>
          </p:cNvPr>
          <p:cNvSpPr txBox="1"/>
          <p:nvPr/>
        </p:nvSpPr>
        <p:spPr>
          <a:xfrm>
            <a:off x="9722292" y="72442"/>
            <a:ext cx="630301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IC</a:t>
            </a:r>
            <a:r>
              <a:rPr lang="en-CA" sz="2000" baseline="-25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xmlns="" id="{207873DB-7F2C-4ECA-93AC-95FBE9CFF49E}"/>
              </a:ext>
            </a:extLst>
          </p:cNvPr>
          <p:cNvSpPr/>
          <p:nvPr/>
        </p:nvSpPr>
        <p:spPr>
          <a:xfrm>
            <a:off x="11316858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6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xmlns="" id="{00BACA41-49C0-4C39-A096-5DAADC00E305}"/>
              </a:ext>
            </a:extLst>
          </p:cNvPr>
          <p:cNvCxnSpPr>
            <a:cxnSpLocks/>
            <a:stCxn id="88" idx="0"/>
          </p:cNvCxnSpPr>
          <p:nvPr/>
        </p:nvCxnSpPr>
        <p:spPr>
          <a:xfrm flipV="1">
            <a:off x="11520487" y="517055"/>
            <a:ext cx="0" cy="11245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9B6A4621-7C61-4CF3-9FDB-5A04E011CB15}"/>
              </a:ext>
            </a:extLst>
          </p:cNvPr>
          <p:cNvSpPr txBox="1"/>
          <p:nvPr/>
        </p:nvSpPr>
        <p:spPr>
          <a:xfrm>
            <a:off x="10652776" y="72442"/>
            <a:ext cx="1864613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e-attachment</a:t>
            </a: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xmlns="" id="{965DB236-9A23-4A6E-91B7-79E125E044B8}"/>
              </a:ext>
            </a:extLst>
          </p:cNvPr>
          <p:cNvSpPr/>
          <p:nvPr/>
        </p:nvSpPr>
        <p:spPr>
          <a:xfrm>
            <a:off x="12853151" y="1641606"/>
            <a:ext cx="407259" cy="335711"/>
          </a:xfrm>
          <a:prstGeom prst="rect">
            <a:avLst/>
          </a:prstGeom>
          <a:solidFill>
            <a:srgbClr val="00206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32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7</a:t>
            </a:r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xmlns="" id="{68381D71-65BB-4B3B-B245-ED0ABF784D9F}"/>
              </a:ext>
            </a:extLst>
          </p:cNvPr>
          <p:cNvCxnSpPr>
            <a:cxnSpLocks/>
            <a:stCxn id="91" idx="0"/>
          </p:cNvCxnSpPr>
          <p:nvPr/>
        </p:nvCxnSpPr>
        <p:spPr>
          <a:xfrm flipV="1">
            <a:off x="13056780" y="517055"/>
            <a:ext cx="0" cy="11245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D2E7630E-EC58-498F-A630-254185811B2D}"/>
              </a:ext>
            </a:extLst>
          </p:cNvPr>
          <p:cNvSpPr txBox="1"/>
          <p:nvPr/>
        </p:nvSpPr>
        <p:spPr>
          <a:xfrm>
            <a:off x="12449495" y="72442"/>
            <a:ext cx="1864613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0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Re-attachment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1BE5B2E2-26C6-4462-9959-AC59B4C2490C}"/>
              </a:ext>
            </a:extLst>
          </p:cNvPr>
          <p:cNvSpPr txBox="1"/>
          <p:nvPr/>
        </p:nvSpPr>
        <p:spPr>
          <a:xfrm>
            <a:off x="6657589" y="2424019"/>
            <a:ext cx="585417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1d</a:t>
            </a:r>
            <a:endParaRPr lang="en-CA" sz="2800" baseline="-250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942E52C4-D079-43E9-B49C-5453E0D4D1CE}"/>
              </a:ext>
            </a:extLst>
          </p:cNvPr>
          <p:cNvSpPr txBox="1"/>
          <p:nvPr/>
        </p:nvSpPr>
        <p:spPr>
          <a:xfrm>
            <a:off x="8205134" y="2424019"/>
            <a:ext cx="585417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2d</a:t>
            </a:r>
            <a:endParaRPr lang="en-CA" sz="2800" baseline="-250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6A588657-DCCF-4275-B121-3944E28DCE1B}"/>
              </a:ext>
            </a:extLst>
          </p:cNvPr>
          <p:cNvSpPr txBox="1"/>
          <p:nvPr/>
        </p:nvSpPr>
        <p:spPr>
          <a:xfrm>
            <a:off x="9785453" y="2424019"/>
            <a:ext cx="585417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3d</a:t>
            </a:r>
            <a:endParaRPr lang="en-CA" sz="2800" baseline="-250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1FDD6215-A2C7-46A6-AD21-EE40D9793735}"/>
              </a:ext>
            </a:extLst>
          </p:cNvPr>
          <p:cNvSpPr txBox="1"/>
          <p:nvPr/>
        </p:nvSpPr>
        <p:spPr>
          <a:xfrm>
            <a:off x="11266460" y="2424019"/>
            <a:ext cx="585417" cy="52322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800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4d</a:t>
            </a:r>
            <a:endParaRPr lang="en-CA" sz="2800" baseline="-250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8" name="Arrow: Down 97">
            <a:extLst>
              <a:ext uri="{FF2B5EF4-FFF2-40B4-BE49-F238E27FC236}">
                <a16:creationId xmlns:a16="http://schemas.microsoft.com/office/drawing/2014/main" xmlns="" id="{9DEEE2C2-5C63-4EC8-8780-57761242B294}"/>
              </a:ext>
            </a:extLst>
          </p:cNvPr>
          <p:cNvSpPr/>
          <p:nvPr/>
        </p:nvSpPr>
        <p:spPr>
          <a:xfrm flipV="1">
            <a:off x="6794964" y="2085095"/>
            <a:ext cx="209133" cy="25316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32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99" name="Arrow: Down 98">
            <a:extLst>
              <a:ext uri="{FF2B5EF4-FFF2-40B4-BE49-F238E27FC236}">
                <a16:creationId xmlns:a16="http://schemas.microsoft.com/office/drawing/2014/main" xmlns="" id="{88224176-D5BC-4B62-B87B-6B0E2A47AABC}"/>
              </a:ext>
            </a:extLst>
          </p:cNvPr>
          <p:cNvSpPr/>
          <p:nvPr/>
        </p:nvSpPr>
        <p:spPr>
          <a:xfrm flipV="1">
            <a:off x="8342508" y="2096345"/>
            <a:ext cx="209133" cy="25316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32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Arrow: Down 99">
            <a:extLst>
              <a:ext uri="{FF2B5EF4-FFF2-40B4-BE49-F238E27FC236}">
                <a16:creationId xmlns:a16="http://schemas.microsoft.com/office/drawing/2014/main" xmlns="" id="{0E4A157A-5545-41A5-B057-FFE9BC82E8E8}"/>
              </a:ext>
            </a:extLst>
          </p:cNvPr>
          <p:cNvSpPr/>
          <p:nvPr/>
        </p:nvSpPr>
        <p:spPr>
          <a:xfrm flipV="1">
            <a:off x="9879630" y="2096345"/>
            <a:ext cx="209133" cy="25316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32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Arrow: Down 100">
            <a:extLst>
              <a:ext uri="{FF2B5EF4-FFF2-40B4-BE49-F238E27FC236}">
                <a16:creationId xmlns:a16="http://schemas.microsoft.com/office/drawing/2014/main" xmlns="" id="{285F30D1-95ED-4827-985D-1CC9BCF46514}"/>
              </a:ext>
            </a:extLst>
          </p:cNvPr>
          <p:cNvSpPr/>
          <p:nvPr/>
        </p:nvSpPr>
        <p:spPr>
          <a:xfrm flipV="1">
            <a:off x="11434054" y="2128258"/>
            <a:ext cx="209133" cy="253160"/>
          </a:xfrm>
          <a:prstGeom prst="down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 sz="32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xmlns="" id="{5CACF379-794B-4D79-A7F8-67760DDFD9F7}"/>
              </a:ext>
            </a:extLst>
          </p:cNvPr>
          <p:cNvSpPr txBox="1"/>
          <p:nvPr/>
        </p:nvSpPr>
        <p:spPr>
          <a:xfrm>
            <a:off x="7144887" y="3110382"/>
            <a:ext cx="4338047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CA" sz="2400" b="1" dirty="0"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</a:rPr>
              <a:t>Whole-cell extract collection</a:t>
            </a:r>
            <a:endParaRPr lang="en-CA" sz="2400" b="1" baseline="-25000" dirty="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ight Bracket 103">
            <a:extLst>
              <a:ext uri="{FF2B5EF4-FFF2-40B4-BE49-F238E27FC236}">
                <a16:creationId xmlns:a16="http://schemas.microsoft.com/office/drawing/2014/main" xmlns="" id="{0CE0BBBF-2F2B-478E-B06A-BC90317C74D8}"/>
              </a:ext>
            </a:extLst>
          </p:cNvPr>
          <p:cNvSpPr/>
          <p:nvPr/>
        </p:nvSpPr>
        <p:spPr>
          <a:xfrm rot="5400000">
            <a:off x="9124969" y="691682"/>
            <a:ext cx="170079" cy="4620956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4000">
              <a:latin typeface="Arial" panose="020B0604020202020204" pitchFamily="34" charset="0"/>
              <a:ea typeface="Verdana" panose="020B060403050404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C9B3A3B9-2B63-4887-B5B9-49BD5973D88C}"/>
              </a:ext>
            </a:extLst>
          </p:cNvPr>
          <p:cNvSpPr txBox="1"/>
          <p:nvPr/>
        </p:nvSpPr>
        <p:spPr>
          <a:xfrm>
            <a:off x="381280" y="60045"/>
            <a:ext cx="399148" cy="59503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3200" b="1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  <a:sym typeface="Helvetica Neue"/>
              </a:rPr>
              <a:t>A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xmlns="" id="{8878FFEC-4CB4-40C3-8295-F6C8AD9BE09C}"/>
              </a:ext>
            </a:extLst>
          </p:cNvPr>
          <p:cNvSpPr txBox="1"/>
          <p:nvPr/>
        </p:nvSpPr>
        <p:spPr>
          <a:xfrm>
            <a:off x="343727" y="4523983"/>
            <a:ext cx="399148" cy="59503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sz="3200" b="1" i="0" u="none" strike="noStrike" cap="none" spc="0" normalizeH="0" baseline="0" dirty="0">
                <a:ln>
                  <a:noFill/>
                </a:ln>
                <a:solidFill>
                  <a:schemeClr val="tx1"/>
                </a:solidFill>
                <a:effectLst/>
                <a:uFillTx/>
                <a:latin typeface="Arial" panose="020B0604020202020204" pitchFamily="34" charset="0"/>
                <a:ea typeface="Verdana" panose="020B0604030504040204" pitchFamily="34" charset="0"/>
                <a:cs typeface="Arial" panose="020B0604020202020204" pitchFamily="34" charset="0"/>
                <a:sym typeface="Helvetica Neue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29448618"/>
      </p:ext>
    </p:extLst>
  </p:cSld>
  <p:clrMapOvr>
    <a:masterClrMapping/>
  </p:clrMapOvr>
</p:sld>
</file>

<file path=ppt/theme/theme1.xml><?xml version="1.0" encoding="utf-8"?>
<a:theme xmlns:a="http://schemas.openxmlformats.org/drawingml/2006/main" name="Theme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1" id="{33D9CCE7-6858-40B7-A260-D0C3548DA631}" vid="{4A55EACB-27DC-440D-A7A0-AB05EE34835F}"/>
    </a:ext>
  </a:extLst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6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Theme1</Template>
  <TotalTime>13894</TotalTime>
  <Words>186</Words>
  <Application>Microsoft Macintosh PowerPoint</Application>
  <PresentationFormat>Custom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 Neue</vt:lpstr>
      <vt:lpstr>Verdana</vt:lpstr>
      <vt:lpstr>Verdana Pro Light</vt:lpstr>
      <vt:lpstr>Theme1</vt:lpstr>
      <vt:lpstr>PowerPoint Presentation</vt:lpstr>
    </vt:vector>
  </TitlesOfParts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US-ROG</dc:creator>
  <cp:lastModifiedBy>Microsoft Office User</cp:lastModifiedBy>
  <cp:revision>746</cp:revision>
  <cp:lastPrinted>2020-10-29T17:41:44Z</cp:lastPrinted>
  <dcterms:modified xsi:type="dcterms:W3CDTF">2020-10-30T13:55:58Z</dcterms:modified>
</cp:coreProperties>
</file>